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fi-FI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76" d="100"/>
          <a:sy n="76" d="100"/>
        </p:scale>
        <p:origin x="-852" y="-3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amgid\Desktop\27032016_Cross%20reactivity%20of%20MGL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amgid\Desktop\27032016_Cross%20reactivity%20of%20MGL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i-FI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lang="fi-FI" sz="1200" b="0"/>
            </a:pPr>
            <a:r>
              <a:rPr lang="fi-FI" sz="1200" b="0" dirty="0" smtClean="0"/>
              <a:t>bioMa695-CA15.3-MGL</a:t>
            </a:r>
            <a:r>
              <a:rPr lang="fi-FI" sz="1200" b="0" baseline="0" dirty="0" smtClean="0"/>
              <a:t> NP</a:t>
            </a:r>
            <a:endParaRPr lang="fi-FI" sz="1200" b="0" dirty="0"/>
          </a:p>
        </c:rich>
      </c:tx>
      <c:layout>
        <c:manualLayout>
          <c:xMode val="edge"/>
          <c:yMode val="edge"/>
          <c:x val="0.30535243558796499"/>
          <c:y val="5.4116914227983676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0920150286331821"/>
          <c:y val="0.19557124528559164"/>
          <c:w val="0.74670617406146789"/>
          <c:h val="0.5899127156541600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cat>
            <c:multiLvlStrRef>
              <c:f>'Lecin Np'!$D$44:$F$45</c:f>
              <c:multiLvlStrCache>
                <c:ptCount val="3"/>
                <c:lvl>
                  <c:pt idx="0">
                    <c:v>CA15.3</c:v>
                  </c:pt>
                  <c:pt idx="1">
                    <c:v>CA125</c:v>
                  </c:pt>
                  <c:pt idx="2">
                    <c:v>PSA</c:v>
                  </c:pt>
                </c:lvl>
                <c:lvl>
                  <c:pt idx="0">
                    <c:v>bioMa695</c:v>
                  </c:pt>
                </c:lvl>
              </c:multiLvlStrCache>
            </c:multiLvlStrRef>
          </c:cat>
          <c:val>
            <c:numRef>
              <c:f>'Lecin Np'!$D$46:$F$46</c:f>
              <c:numCache>
                <c:formatCode>General</c:formatCode>
                <c:ptCount val="3"/>
                <c:pt idx="0">
                  <c:v>25.576086956521738</c:v>
                </c:pt>
                <c:pt idx="1">
                  <c:v>0.12383252818035426</c:v>
                </c:pt>
                <c:pt idx="2">
                  <c:v>8.1667618503712167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A7D-4AF9-8731-987280D6895E}"/>
            </c:ext>
          </c:extLst>
        </c:ser>
        <c:ser>
          <c:idx val="1"/>
          <c:order val="1"/>
          <c:spPr>
            <a:pattFill prst="pct5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cat>
            <c:multiLvlStrRef>
              <c:f>'Lecin Np'!$D$44:$F$45</c:f>
              <c:multiLvlStrCache>
                <c:ptCount val="3"/>
                <c:lvl>
                  <c:pt idx="0">
                    <c:v>CA15.3</c:v>
                  </c:pt>
                  <c:pt idx="1">
                    <c:v>CA125</c:v>
                  </c:pt>
                  <c:pt idx="2">
                    <c:v>PSA</c:v>
                  </c:pt>
                </c:lvl>
                <c:lvl>
                  <c:pt idx="0">
                    <c:v>bioMa695</c:v>
                  </c:pt>
                </c:lvl>
              </c:multiLvlStrCache>
            </c:multiLvlStrRef>
          </c:cat>
          <c:val>
            <c:numRef>
              <c:f>'Lecin Np'!$D$47:$F$47</c:f>
              <c:numCache>
                <c:formatCode>General</c:formatCode>
                <c:ptCount val="3"/>
                <c:pt idx="0" formatCode="0">
                  <c:v>34.595072463768119</c:v>
                </c:pt>
                <c:pt idx="1">
                  <c:v>0.13896940418679549</c:v>
                </c:pt>
                <c:pt idx="2">
                  <c:v>0.1212164477441462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4A7D-4AF9-8731-987280D6895E}"/>
            </c:ext>
          </c:extLst>
        </c:ser>
        <c:ser>
          <c:idx val="2"/>
          <c:order val="2"/>
          <c:spPr>
            <a:solidFill>
              <a:schemeClr val="tx1"/>
            </a:solidFill>
          </c:spPr>
          <c:invertIfNegative val="0"/>
          <c:cat>
            <c:multiLvlStrRef>
              <c:f>'Lecin Np'!$D$44:$F$45</c:f>
              <c:multiLvlStrCache>
                <c:ptCount val="3"/>
                <c:lvl>
                  <c:pt idx="0">
                    <c:v>CA15.3</c:v>
                  </c:pt>
                  <c:pt idx="1">
                    <c:v>CA125</c:v>
                  </c:pt>
                  <c:pt idx="2">
                    <c:v>PSA</c:v>
                  </c:pt>
                </c:lvl>
                <c:lvl>
                  <c:pt idx="0">
                    <c:v>bioMa695</c:v>
                  </c:pt>
                </c:lvl>
              </c:multiLvlStrCache>
            </c:multiLvlStrRef>
          </c:cat>
          <c:val>
            <c:numRef>
              <c:f>'Lecin Np'!$D$48:$F$48</c:f>
              <c:numCache>
                <c:formatCode>General</c:formatCode>
                <c:ptCount val="3"/>
                <c:pt idx="0">
                  <c:v>129.2431884057971</c:v>
                </c:pt>
                <c:pt idx="1">
                  <c:v>2.107085346215781</c:v>
                </c:pt>
                <c:pt idx="2">
                  <c:v>1.179326099371787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4A7D-4AF9-8731-987280D6895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0329600"/>
        <c:axId val="150333312"/>
      </c:barChart>
      <c:catAx>
        <c:axId val="150329600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txPr>
          <a:bodyPr/>
          <a:lstStyle/>
          <a:p>
            <a:pPr>
              <a:defRPr lang="fi-FI" sz="900"/>
            </a:pPr>
            <a:endParaRPr lang="fi-FI"/>
          </a:p>
        </c:txPr>
        <c:crossAx val="150333312"/>
        <c:crosses val="autoZero"/>
        <c:auto val="1"/>
        <c:lblAlgn val="ctr"/>
        <c:lblOffset val="100"/>
        <c:noMultiLvlLbl val="0"/>
      </c:catAx>
      <c:valAx>
        <c:axId val="150333312"/>
        <c:scaling>
          <c:orientation val="minMax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 lang="fi-FI" b="0"/>
                </a:pPr>
                <a:r>
                  <a:rPr lang="fi-FI" b="0" dirty="0" smtClean="0"/>
                  <a:t>S/B</a:t>
                </a:r>
                <a:endParaRPr lang="fi-FI" b="0" dirty="0"/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lang="fi-FI" sz="800"/>
            </a:pPr>
            <a:endParaRPr lang="fi-FI"/>
          </a:p>
        </c:txPr>
        <c:crossAx val="15032960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i-FI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lang="fi-FI" sz="1200" b="0"/>
            </a:pPr>
            <a:r>
              <a:rPr lang="fi-FI" sz="1200" b="0" dirty="0" smtClean="0"/>
              <a:t>bioMa552-CA15.3-MGL</a:t>
            </a:r>
            <a:r>
              <a:rPr lang="fi-FI" sz="1200" b="0" baseline="0" dirty="0" smtClean="0"/>
              <a:t> NP</a:t>
            </a:r>
            <a:endParaRPr lang="fi-FI" sz="1200" b="0" dirty="0"/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cat>
            <c:multiLvlStrRef>
              <c:f>'Lecin Np'!$I$44:$K$45</c:f>
              <c:multiLvlStrCache>
                <c:ptCount val="3"/>
                <c:lvl>
                  <c:pt idx="0">
                    <c:v>CA15.3</c:v>
                  </c:pt>
                  <c:pt idx="1">
                    <c:v>CA125</c:v>
                  </c:pt>
                  <c:pt idx="2">
                    <c:v>PSA</c:v>
                  </c:pt>
                </c:lvl>
                <c:lvl>
                  <c:pt idx="0">
                    <c:v>bioMa552</c:v>
                  </c:pt>
                </c:lvl>
              </c:multiLvlStrCache>
            </c:multiLvlStrRef>
          </c:cat>
          <c:val>
            <c:numRef>
              <c:f>'Lecin Np'!$I$46:$K$46</c:f>
              <c:numCache>
                <c:formatCode>0.0</c:formatCode>
                <c:ptCount val="3"/>
                <c:pt idx="0">
                  <c:v>8.0692849378515046</c:v>
                </c:pt>
                <c:pt idx="1">
                  <c:v>0.10095497953615282</c:v>
                </c:pt>
                <c:pt idx="2">
                  <c:v>9.6065699006875491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9D2-4061-9841-C395BD4A193C}"/>
            </c:ext>
          </c:extLst>
        </c:ser>
        <c:ser>
          <c:idx val="1"/>
          <c:order val="1"/>
          <c:spPr>
            <a:pattFill prst="pct5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cat>
            <c:multiLvlStrRef>
              <c:f>'Lecin Np'!$I$44:$K$45</c:f>
              <c:multiLvlStrCache>
                <c:ptCount val="3"/>
                <c:lvl>
                  <c:pt idx="0">
                    <c:v>CA15.3</c:v>
                  </c:pt>
                  <c:pt idx="1">
                    <c:v>CA125</c:v>
                  </c:pt>
                  <c:pt idx="2">
                    <c:v>PSA</c:v>
                  </c:pt>
                </c:lvl>
                <c:lvl>
                  <c:pt idx="0">
                    <c:v>bioMa552</c:v>
                  </c:pt>
                </c:lvl>
              </c:multiLvlStrCache>
            </c:multiLvlStrRef>
          </c:cat>
          <c:val>
            <c:numRef>
              <c:f>'Lecin Np'!$I$47:$K$47</c:f>
              <c:numCache>
                <c:formatCode>0.0</c:formatCode>
                <c:ptCount val="3"/>
                <c:pt idx="0">
                  <c:v>13.064700600217401</c:v>
                </c:pt>
                <c:pt idx="1">
                  <c:v>0.11894295386791977</c:v>
                </c:pt>
                <c:pt idx="2">
                  <c:v>8.6426803731201221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49D2-4061-9841-C395BD4A193C}"/>
            </c:ext>
          </c:extLst>
        </c:ser>
        <c:ser>
          <c:idx val="2"/>
          <c:order val="2"/>
          <c:spPr>
            <a:solidFill>
              <a:schemeClr val="tx1"/>
            </a:solidFill>
          </c:spPr>
          <c:invertIfNegative val="0"/>
          <c:cat>
            <c:multiLvlStrRef>
              <c:f>'Lecin Np'!$I$44:$K$45</c:f>
              <c:multiLvlStrCache>
                <c:ptCount val="3"/>
                <c:lvl>
                  <c:pt idx="0">
                    <c:v>CA15.3</c:v>
                  </c:pt>
                  <c:pt idx="1">
                    <c:v>CA125</c:v>
                  </c:pt>
                  <c:pt idx="2">
                    <c:v>PSA</c:v>
                  </c:pt>
                </c:lvl>
                <c:lvl>
                  <c:pt idx="0">
                    <c:v>bioMa552</c:v>
                  </c:pt>
                </c:lvl>
              </c:multiLvlStrCache>
            </c:multiLvlStrRef>
          </c:cat>
          <c:val>
            <c:numRef>
              <c:f>'Lecin Np'!$I$48:$K$48</c:f>
              <c:numCache>
                <c:formatCode>0.0</c:formatCode>
                <c:ptCount val="3"/>
                <c:pt idx="0">
                  <c:v>32.681695732312484</c:v>
                </c:pt>
                <c:pt idx="1">
                  <c:v>0.12935172553180738</c:v>
                </c:pt>
                <c:pt idx="2">
                  <c:v>0.1449647820293166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49D2-4061-9841-C395BD4A193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1724800"/>
        <c:axId val="151726336"/>
      </c:barChart>
      <c:catAx>
        <c:axId val="151724800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txPr>
          <a:bodyPr/>
          <a:lstStyle/>
          <a:p>
            <a:pPr>
              <a:defRPr lang="fi-FI" sz="900"/>
            </a:pPr>
            <a:endParaRPr lang="fi-FI"/>
          </a:p>
        </c:txPr>
        <c:crossAx val="151726336"/>
        <c:crosses val="autoZero"/>
        <c:auto val="1"/>
        <c:lblAlgn val="ctr"/>
        <c:lblOffset val="100"/>
        <c:noMultiLvlLbl val="0"/>
      </c:catAx>
      <c:valAx>
        <c:axId val="151726336"/>
        <c:scaling>
          <c:orientation val="minMax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 lang="fi-FI" b="0"/>
                </a:pPr>
                <a:r>
                  <a:rPr lang="fi-FI" b="0" dirty="0" smtClean="0"/>
                  <a:t>S/B</a:t>
                </a:r>
                <a:endParaRPr lang="fi-FI" b="0" dirty="0"/>
              </a:p>
            </c:rich>
          </c:tx>
          <c:layout>
            <c:manualLayout>
              <c:xMode val="edge"/>
              <c:yMode val="edge"/>
              <c:x val="1.2396992704320983E-2"/>
              <c:y val="0.37567160882352568"/>
            </c:manualLayout>
          </c:layout>
          <c:overlay val="0"/>
        </c:title>
        <c:numFmt formatCode="0.0" sourceLinked="1"/>
        <c:majorTickMark val="out"/>
        <c:minorTickMark val="none"/>
        <c:tickLblPos val="nextTo"/>
        <c:txPr>
          <a:bodyPr/>
          <a:lstStyle/>
          <a:p>
            <a:pPr>
              <a:defRPr lang="fi-FI" sz="800"/>
            </a:pPr>
            <a:endParaRPr lang="fi-FI"/>
          </a:p>
        </c:txPr>
        <c:crossAx val="15172480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B8419-607E-434C-9606-AD9CA6D02FD6}" type="datetimeFigureOut">
              <a:rPr lang="fi-FI" smtClean="0"/>
              <a:t>15.7.2019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61944-E378-4941-B214-FA0180A1E215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0060574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B8419-607E-434C-9606-AD9CA6D02FD6}" type="datetimeFigureOut">
              <a:rPr lang="fi-FI" smtClean="0"/>
              <a:t>15.7.2019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61944-E378-4941-B214-FA0180A1E215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8026339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B8419-607E-434C-9606-AD9CA6D02FD6}" type="datetimeFigureOut">
              <a:rPr lang="fi-FI" smtClean="0"/>
              <a:t>15.7.2019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61944-E378-4941-B214-FA0180A1E215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9580928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B8419-607E-434C-9606-AD9CA6D02FD6}" type="datetimeFigureOut">
              <a:rPr lang="fi-FI" smtClean="0"/>
              <a:t>15.7.2019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61944-E378-4941-B214-FA0180A1E215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8270220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B8419-607E-434C-9606-AD9CA6D02FD6}" type="datetimeFigureOut">
              <a:rPr lang="fi-FI" smtClean="0"/>
              <a:t>15.7.2019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61944-E378-4941-B214-FA0180A1E215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40711183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B8419-607E-434C-9606-AD9CA6D02FD6}" type="datetimeFigureOut">
              <a:rPr lang="fi-FI" smtClean="0"/>
              <a:t>15.7.2019</a:t>
            </a:fld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61944-E378-4941-B214-FA0180A1E215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776773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B8419-607E-434C-9606-AD9CA6D02FD6}" type="datetimeFigureOut">
              <a:rPr lang="fi-FI" smtClean="0"/>
              <a:t>15.7.2019</a:t>
            </a:fld>
            <a:endParaRPr lang="fi-FI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61944-E378-4941-B214-FA0180A1E215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6039798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B8419-607E-434C-9606-AD9CA6D02FD6}" type="datetimeFigureOut">
              <a:rPr lang="fi-FI" smtClean="0"/>
              <a:t>15.7.2019</a:t>
            </a:fld>
            <a:endParaRPr lang="fi-FI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61944-E378-4941-B214-FA0180A1E215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2737640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B8419-607E-434C-9606-AD9CA6D02FD6}" type="datetimeFigureOut">
              <a:rPr lang="fi-FI" smtClean="0"/>
              <a:t>15.7.2019</a:t>
            </a:fld>
            <a:endParaRPr lang="fi-FI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61944-E378-4941-B214-FA0180A1E215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5898326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B8419-607E-434C-9606-AD9CA6D02FD6}" type="datetimeFigureOut">
              <a:rPr lang="fi-FI" smtClean="0"/>
              <a:t>15.7.2019</a:t>
            </a:fld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61944-E378-4941-B214-FA0180A1E215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4758374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i-FI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2B8419-607E-434C-9606-AD9CA6D02FD6}" type="datetimeFigureOut">
              <a:rPr lang="fi-FI" smtClean="0"/>
              <a:t>15.7.2019</a:t>
            </a:fld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61944-E378-4941-B214-FA0180A1E215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1192025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2B8419-607E-434C-9606-AD9CA6D02FD6}" type="datetimeFigureOut">
              <a:rPr lang="fi-FI" smtClean="0"/>
              <a:t>15.7.2019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961944-E378-4941-B214-FA0180A1E215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0786339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i-FI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/>
          </p:nvPr>
        </p:nvGraphicFramePr>
        <p:xfrm>
          <a:off x="2249007" y="1916832"/>
          <a:ext cx="3168352" cy="25814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/>
          <p:cNvGraphicFramePr>
            <a:graphicFrameLocks/>
          </p:cNvGraphicFramePr>
          <p:nvPr>
            <p:extLst/>
          </p:nvPr>
        </p:nvGraphicFramePr>
        <p:xfrm>
          <a:off x="6384032" y="1916833"/>
          <a:ext cx="3073326" cy="255706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1" name="Rectangle 10"/>
          <p:cNvSpPr/>
          <p:nvPr/>
        </p:nvSpPr>
        <p:spPr>
          <a:xfrm>
            <a:off x="1847529" y="5013177"/>
            <a:ext cx="8493864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sz="1200" b="1" dirty="0" smtClean="0"/>
              <a:t>S2 </a:t>
            </a:r>
            <a:r>
              <a:rPr lang="fi-FI" sz="1200" b="1" dirty="0" err="1" smtClean="0"/>
              <a:t>Fig</a:t>
            </a:r>
            <a:r>
              <a:rPr lang="fi-FI" sz="1200" b="1" dirty="0" smtClean="0"/>
              <a:t>.  </a:t>
            </a:r>
            <a:r>
              <a:rPr lang="fi-FI" sz="1200" b="1" dirty="0" err="1"/>
              <a:t>Assay</a:t>
            </a:r>
            <a:r>
              <a:rPr lang="fi-FI" sz="1200" b="1" dirty="0"/>
              <a:t> cross-</a:t>
            </a:r>
            <a:r>
              <a:rPr lang="fi-FI" sz="1200" b="1" dirty="0" err="1"/>
              <a:t>reactivity</a:t>
            </a:r>
            <a:r>
              <a:rPr lang="fi-FI" sz="1200" b="1" dirty="0"/>
              <a:t> </a:t>
            </a:r>
            <a:r>
              <a:rPr lang="fi-FI" sz="1200" b="1" dirty="0" err="1"/>
              <a:t>with</a:t>
            </a:r>
            <a:r>
              <a:rPr lang="fi-FI" sz="1200" b="1" dirty="0"/>
              <a:t> </a:t>
            </a:r>
            <a:r>
              <a:rPr lang="fi-FI" sz="1200" b="1" dirty="0" err="1"/>
              <a:t>other</a:t>
            </a:r>
            <a:r>
              <a:rPr lang="fi-FI" sz="1200" b="1" dirty="0"/>
              <a:t> </a:t>
            </a:r>
            <a:r>
              <a:rPr lang="fi-FI" sz="1200" b="1" dirty="0" err="1"/>
              <a:t>common</a:t>
            </a:r>
            <a:r>
              <a:rPr lang="fi-FI" sz="1200" b="1" dirty="0"/>
              <a:t> </a:t>
            </a:r>
            <a:r>
              <a:rPr lang="fi-FI" sz="1200" b="1" dirty="0" err="1"/>
              <a:t>tumor</a:t>
            </a:r>
            <a:r>
              <a:rPr lang="fi-FI" sz="1200" b="1" dirty="0"/>
              <a:t> </a:t>
            </a:r>
            <a:r>
              <a:rPr lang="fi-FI" sz="1200" b="1" dirty="0" err="1"/>
              <a:t>markers</a:t>
            </a:r>
            <a:r>
              <a:rPr lang="fi-FI" sz="1200" b="1" dirty="0"/>
              <a:t>. </a:t>
            </a:r>
            <a:r>
              <a:rPr lang="fi-FI" sz="1200" dirty="0"/>
              <a:t>No cross reactivity with CA15-3 </a:t>
            </a:r>
            <a:r>
              <a:rPr lang="fi-FI" sz="1200" dirty="0" err="1"/>
              <a:t>lectin</a:t>
            </a:r>
            <a:r>
              <a:rPr lang="fi-FI" sz="1200" dirty="0"/>
              <a:t> </a:t>
            </a:r>
            <a:r>
              <a:rPr lang="fi-FI" sz="1200" dirty="0" err="1"/>
              <a:t>assay</a:t>
            </a:r>
            <a:r>
              <a:rPr lang="fi-FI" sz="1200" dirty="0"/>
              <a:t> </a:t>
            </a:r>
            <a:r>
              <a:rPr lang="fi-FI" sz="1200" dirty="0" err="1"/>
              <a:t>was</a:t>
            </a:r>
            <a:r>
              <a:rPr lang="fi-FI" sz="1200" dirty="0"/>
              <a:t> </a:t>
            </a:r>
            <a:r>
              <a:rPr lang="fi-FI" sz="1200" dirty="0" err="1"/>
              <a:t>observed</a:t>
            </a:r>
            <a:r>
              <a:rPr lang="fi-FI" sz="1200" dirty="0"/>
              <a:t> with </a:t>
            </a:r>
          </a:p>
          <a:p>
            <a:r>
              <a:rPr lang="fi-FI" sz="1200" dirty="0" err="1"/>
              <a:t>ovarian</a:t>
            </a:r>
            <a:r>
              <a:rPr lang="fi-FI" sz="1200" dirty="0"/>
              <a:t> </a:t>
            </a:r>
            <a:r>
              <a:rPr lang="fi-FI" sz="1200" dirty="0" err="1"/>
              <a:t>cancer</a:t>
            </a:r>
            <a:r>
              <a:rPr lang="fi-FI" sz="1200" dirty="0"/>
              <a:t> </a:t>
            </a:r>
            <a:r>
              <a:rPr lang="fi-FI" sz="1200" dirty="0" err="1"/>
              <a:t>cell</a:t>
            </a:r>
            <a:r>
              <a:rPr lang="fi-FI" sz="1200" dirty="0"/>
              <a:t> </a:t>
            </a:r>
            <a:r>
              <a:rPr lang="fi-FI" sz="1200" dirty="0" err="1"/>
              <a:t>line</a:t>
            </a:r>
            <a:r>
              <a:rPr lang="fi-FI" sz="1200" dirty="0"/>
              <a:t> </a:t>
            </a:r>
            <a:r>
              <a:rPr lang="fi-FI" sz="1200" dirty="0" err="1"/>
              <a:t>associated</a:t>
            </a:r>
            <a:r>
              <a:rPr lang="fi-FI" sz="1200" dirty="0"/>
              <a:t> CA125 and </a:t>
            </a:r>
            <a:r>
              <a:rPr lang="fi-FI" sz="1200" dirty="0" err="1"/>
              <a:t>prostate</a:t>
            </a:r>
            <a:r>
              <a:rPr lang="fi-FI" sz="1200" dirty="0"/>
              <a:t> </a:t>
            </a:r>
            <a:r>
              <a:rPr lang="fi-FI" sz="1200" dirty="0" err="1"/>
              <a:t>cancer</a:t>
            </a:r>
            <a:r>
              <a:rPr lang="fi-FI" sz="1200" dirty="0"/>
              <a:t> </a:t>
            </a:r>
            <a:r>
              <a:rPr lang="fi-FI" sz="1200" dirty="0" err="1"/>
              <a:t>associated</a:t>
            </a:r>
            <a:r>
              <a:rPr lang="fi-FI" sz="1200" dirty="0"/>
              <a:t> </a:t>
            </a:r>
            <a:r>
              <a:rPr lang="fi-FI" sz="1200" dirty="0" err="1" smtClean="0"/>
              <a:t>LnCAp</a:t>
            </a:r>
            <a:r>
              <a:rPr lang="fi-FI" sz="1200" dirty="0" smtClean="0"/>
              <a:t> </a:t>
            </a:r>
            <a:r>
              <a:rPr lang="fi-FI" sz="1200" dirty="0"/>
              <a:t>PSA</a:t>
            </a:r>
          </a:p>
        </p:txBody>
      </p:sp>
    </p:spTree>
    <p:extLst>
      <p:ext uri="{BB962C8B-B14F-4D97-AF65-F5344CB8AC3E}">
        <p14:creationId xmlns:p14="http://schemas.microsoft.com/office/powerpoint/2010/main" val="32976841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9</Words>
  <Application>Microsoft Office PowerPoint</Application>
  <PresentationFormat>Custom</PresentationFormat>
  <Paragraphs>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Turku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onas Terävä</dc:creator>
  <cp:lastModifiedBy>Kamlesh Gidwani</cp:lastModifiedBy>
  <cp:revision>2</cp:revision>
  <dcterms:created xsi:type="dcterms:W3CDTF">2019-07-15T07:32:42Z</dcterms:created>
  <dcterms:modified xsi:type="dcterms:W3CDTF">2019-07-15T09:07:01Z</dcterms:modified>
</cp:coreProperties>
</file>